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74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64088" y="4512997"/>
            <a:ext cx="324036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igure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S1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hromosome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behavior of hybrid. A and B pachytene, C and D diakinesis, E metaphase I, F anaphase I, G telophase I, H prophase II, I metaphase II, J anaphase II, K telophase II, L tetrad stage. Bar=10</a:t>
            </a:r>
            <a:r>
              <a:rPr lang="el-GR" altLang="zh-CN" sz="16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m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图片 6" descr="D:\实验\袁赟毕业论文-文件夹\整理袁赟毕业论文数据\减数分裂图-我\F1-10X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260648"/>
            <a:ext cx="5040560" cy="638132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28072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East-1</cp:lastModifiedBy>
  <cp:revision>10</cp:revision>
  <dcterms:modified xsi:type="dcterms:W3CDTF">2019-03-08T01:59:12Z</dcterms:modified>
</cp:coreProperties>
</file>